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slides/slide1.xml" ContentType="application/vnd.openxmlformats-officedocument.presentationml.slide+xml"/>
  <Override PartName="/ppt/presentation.xml" ContentType="application/vnd.openxmlformats-officedocument.presentationml.presentation.main+xml"/>
  <Override PartName="/ppt/notesSlides/notesSlide1.xml" ContentType="application/vnd.openxmlformats-officedocument.presentationml.notesSlid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8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55"/>
  </p:normalViewPr>
  <p:slideViewPr>
    <p:cSldViewPr snapToGrid="0" snapToObjects="1">
      <p:cViewPr varScale="1">
        <p:scale>
          <a:sx n="110" d="100"/>
          <a:sy n="110" d="100"/>
        </p:scale>
        <p:origin x="6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531E9F-E6EC-AF4F-8BF7-CAAE5B523CBA}" type="datetimeFigureOut">
              <a:rPr lang="en-US" smtClean="0"/>
              <a:t>3/29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C50BF0-B6F9-DC4C-B084-A6665E82D7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7826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705949-0F67-624F-9A1A-30C9F07C614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5576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64736-C868-FB49-87AF-5DB87963AB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190EBE-028D-7946-8F98-CCF477D1C4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024259-D12F-4240-9165-89EC6B92A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B774D4-D4BE-A247-BB2B-3CB135A51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0194E6-EB3D-BF4D-BE1D-813F18165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29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644F2-D879-5441-B333-38535BE2D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9A41DD-5FD3-FB4D-9A4B-98A9BEA261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C38596-8A93-924A-8692-C85490EC5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589392-1CC8-6942-8D57-7AB54C001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E5FD5-D78D-314B-AE84-4335F6393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803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DC85F5-86AD-464E-9D28-87539C5245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A9C4CB-E264-1E40-84FB-2DE1C43F15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03DFCB-C400-9441-96EC-E207442577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7FE9A0-635B-F24C-B942-3EBCEFBD0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8DB60-0B9F-B14E-9BB9-BC5DF9243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65358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167149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9FE04-D678-1B4C-AC1F-33400EB54A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10DE61-6FD6-0A4E-8093-1A04C12A9E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BA26C3-812D-6D49-8EC3-6BB0504F7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B90648-8B7A-5C4A-830F-FFF210D3E6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C94D33-F1F3-C847-AD92-CA386AD75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321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271F4A-267D-F943-AE88-A1C4825C0D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185157-C587-4B46-9523-3B2AC2711B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9A248-14C9-6641-A7A1-BF985B0BC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0AD951-B8C1-324A-8339-96EBB9E487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2FC0F9-4557-F74F-88D1-751127262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639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F6D854-B60A-2D4E-8AB1-85FA305CF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888553-F451-A140-BD4F-77D0C4B5AA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0CF04F-27BA-7C4F-AE5F-DCCF68DC6E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2B6E84-A1F1-B840-A6F5-CA6B78B9A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F116D9-5144-9540-8539-32E4C9C74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6CF73F-331B-8047-9427-E1AD586C3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055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9D97C1-EE0E-7442-A7A1-729AD6AEC3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D18908-6E20-7049-A1B4-94379D5BFA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1D87B4-EF2D-A94F-8C5C-057C1EB14F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D02DD6-9781-7346-B97E-8A59EB2492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6988CB-B288-FE48-8933-06533EBC5F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C725C8-5BF2-5B47-A7A4-AA6E1E8F9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39AF6EF-BA74-AD4A-9667-DC23FE661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4E3A557-4497-9649-B6CC-85B04564B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169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6A86A-8388-3846-A79B-28CBF99879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C7DF28F-5F06-C746-8E24-BA807467D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116D119-3270-364E-887D-F9AE90ABC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2E846B-C132-1D41-8B22-4F5E8F3A2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125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1EE295-052B-C448-8763-8BBFA3C45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E3D355-7CB6-614F-AF0E-74A6F5F1B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8CA2D9-9F19-974D-AF40-863E0F54A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4929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453673-5FB9-0841-8D96-5950D836E7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2A732E-B1A8-9447-A351-3E411AEB4B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D4368C-F4C3-684B-AFD3-A6A5BB7BEB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C2E963-6C42-3343-B522-A73AA0EE9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1F2451-7344-E440-AA8D-D044C2490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114D0D-24DC-264A-9BDB-8B1CAFD37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964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314F97-7259-664E-8992-281D6C6A1A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7A9367-4EF5-AB49-9E80-D8AE40F01D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72D4FD-BE04-DF46-8BD5-BBA8CF1DBA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CDFF0D-DEAA-B245-81E3-8D4BEF1FF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5DC53E-A6F4-6C44-A965-3294C803B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99841B-D74F-E14B-8EC5-580B22AE0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17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0A76556-E615-8C4D-8136-D4CD6E4A0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C2D683-9BC8-9142-8B4E-4CE775871A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E20E2B-ED12-944E-98D7-6EBB2AF08D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C8D05-3473-4D4C-896A-94634A59F127}" type="datetimeFigureOut">
              <a:rPr lang="en-US" smtClean="0"/>
              <a:t>3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04569C-DFF4-2448-B2D3-44CD516CC6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41648-5B7A-5B44-9BD7-60446E2463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BCC383-7E45-C944-B9AD-87D4A72C9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596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hevron 6">
            <a:extLst>
              <a:ext uri="{FF2B5EF4-FFF2-40B4-BE49-F238E27FC236}">
                <a16:creationId xmlns:a16="http://schemas.microsoft.com/office/drawing/2014/main" id="{3653E7E6-456C-9748-A1FD-0D51B20ACB45}"/>
              </a:ext>
            </a:extLst>
          </p:cNvPr>
          <p:cNvSpPr/>
          <p:nvPr/>
        </p:nvSpPr>
        <p:spPr>
          <a:xfrm>
            <a:off x="4118112" y="4851232"/>
            <a:ext cx="7649819" cy="1785104"/>
          </a:xfrm>
          <a:prstGeom prst="chevron">
            <a:avLst>
              <a:gd name="adj" fmla="val 23274"/>
            </a:avLst>
          </a:prstGeom>
          <a:solidFill>
            <a:srgbClr val="FF9300"/>
          </a:solidFill>
          <a:ln>
            <a:solidFill>
              <a:srgbClr val="FF9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2CFE561-F5BD-3043-A4A8-39A02743FEFA}"/>
              </a:ext>
            </a:extLst>
          </p:cNvPr>
          <p:cNvSpPr txBox="1"/>
          <p:nvPr/>
        </p:nvSpPr>
        <p:spPr>
          <a:xfrm>
            <a:off x="5552662" y="5528340"/>
            <a:ext cx="663933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b="1" dirty="0">
                <a:solidFill>
                  <a:schemeClr val="bg1"/>
                </a:solidFill>
                <a:latin typeface="Arial"/>
                <a:cs typeface="Arial"/>
              </a:rPr>
              <a:t>“Professional Vision Statement”</a:t>
            </a:r>
            <a:endParaRPr lang="en-US" sz="2200" b="1" dirty="0">
              <a:solidFill>
                <a:schemeClr val="bg1"/>
              </a:solidFill>
            </a:endParaRPr>
          </a:p>
        </p:txBody>
      </p:sp>
      <p:sp>
        <p:nvSpPr>
          <p:cNvPr id="5" name="Chevron 4">
            <a:extLst>
              <a:ext uri="{FF2B5EF4-FFF2-40B4-BE49-F238E27FC236}">
                <a16:creationId xmlns:a16="http://schemas.microsoft.com/office/drawing/2014/main" id="{AC8793D6-2614-4E42-950D-B0E60AC6E683}"/>
              </a:ext>
            </a:extLst>
          </p:cNvPr>
          <p:cNvSpPr/>
          <p:nvPr/>
        </p:nvSpPr>
        <p:spPr>
          <a:xfrm>
            <a:off x="424069" y="4851232"/>
            <a:ext cx="3949147" cy="1785104"/>
          </a:xfrm>
          <a:prstGeom prst="chevron">
            <a:avLst>
              <a:gd name="adj" fmla="val 23274"/>
            </a:avLst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E0A5519-9A0A-DF47-A629-BAA00CEEB4B8}"/>
              </a:ext>
            </a:extLst>
          </p:cNvPr>
          <p:cNvSpPr txBox="1"/>
          <p:nvPr/>
        </p:nvSpPr>
        <p:spPr>
          <a:xfrm>
            <a:off x="801758" y="4851232"/>
            <a:ext cx="3316354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>
              <a:buAutoNum type="arabicParenR"/>
            </a:pPr>
            <a:r>
              <a:rPr lang="en-US" sz="2200" b="1" dirty="0">
                <a:solidFill>
                  <a:schemeClr val="bg1"/>
                </a:solidFill>
              </a:rPr>
              <a:t>Character Strength #1</a:t>
            </a:r>
          </a:p>
          <a:p>
            <a:pPr marL="457200" indent="-457200">
              <a:buAutoNum type="arabicParenR"/>
            </a:pPr>
            <a:r>
              <a:rPr lang="en-US" sz="2200" b="1" dirty="0">
                <a:solidFill>
                  <a:schemeClr val="bg1"/>
                </a:solidFill>
              </a:rPr>
              <a:t>Character Strength #2</a:t>
            </a:r>
          </a:p>
          <a:p>
            <a:pPr marL="457200" indent="-457200">
              <a:buAutoNum type="arabicParenR"/>
            </a:pPr>
            <a:r>
              <a:rPr lang="en-US" sz="2200" b="1" dirty="0">
                <a:solidFill>
                  <a:schemeClr val="bg1"/>
                </a:solidFill>
              </a:rPr>
              <a:t>Character Strength #3</a:t>
            </a:r>
          </a:p>
          <a:p>
            <a:pPr marL="457200" indent="-457200">
              <a:buAutoNum type="arabicParenR"/>
            </a:pPr>
            <a:r>
              <a:rPr lang="en-US" sz="2200" b="1" dirty="0">
                <a:solidFill>
                  <a:schemeClr val="bg1"/>
                </a:solidFill>
              </a:rPr>
              <a:t>Character Strength #4</a:t>
            </a:r>
          </a:p>
          <a:p>
            <a:pPr marL="457200" indent="-457200">
              <a:buAutoNum type="arabicParenR"/>
            </a:pPr>
            <a:r>
              <a:rPr lang="en-US" sz="2200" b="1" dirty="0">
                <a:solidFill>
                  <a:schemeClr val="bg1"/>
                </a:solidFill>
              </a:rPr>
              <a:t>Character Strength #5</a:t>
            </a:r>
          </a:p>
        </p:txBody>
      </p:sp>
      <p:graphicFrame>
        <p:nvGraphicFramePr>
          <p:cNvPr id="8" name="Table 12">
            <a:extLst>
              <a:ext uri="{FF2B5EF4-FFF2-40B4-BE49-F238E27FC236}">
                <a16:creationId xmlns:a16="http://schemas.microsoft.com/office/drawing/2014/main" id="{4C3E8A5D-3072-384A-8BBF-782760C6C8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5279326"/>
              </p:ext>
            </p:extLst>
          </p:nvPr>
        </p:nvGraphicFramePr>
        <p:xfrm>
          <a:off x="424069" y="1114216"/>
          <a:ext cx="11343862" cy="316618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88859">
                  <a:extLst>
                    <a:ext uri="{9D8B030D-6E8A-4147-A177-3AD203B41FA5}">
                      <a16:colId xmlns:a16="http://schemas.microsoft.com/office/drawing/2014/main" val="766863355"/>
                    </a:ext>
                  </a:extLst>
                </a:gridCol>
                <a:gridCol w="4226487">
                  <a:extLst>
                    <a:ext uri="{9D8B030D-6E8A-4147-A177-3AD203B41FA5}">
                      <a16:colId xmlns:a16="http://schemas.microsoft.com/office/drawing/2014/main" val="3089200218"/>
                    </a:ext>
                  </a:extLst>
                </a:gridCol>
                <a:gridCol w="4928516">
                  <a:extLst>
                    <a:ext uri="{9D8B030D-6E8A-4147-A177-3AD203B41FA5}">
                      <a16:colId xmlns:a16="http://schemas.microsoft.com/office/drawing/2014/main" val="2032724738"/>
                    </a:ext>
                  </a:extLst>
                </a:gridCol>
              </a:tblGrid>
              <a:tr h="565325">
                <a:tc>
                  <a:txBody>
                    <a:bodyPr/>
                    <a:lstStyle/>
                    <a:p>
                      <a:pPr algn="ctr"/>
                      <a:r>
                        <a:rPr lang="en-US" sz="2800" dirty="0"/>
                        <a:t>Role</a:t>
                      </a:r>
                    </a:p>
                  </a:txBody>
                  <a:tcPr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dirty="0"/>
                        <a:t>1-Year SMART Goal</a:t>
                      </a:r>
                    </a:p>
                  </a:txBody>
                  <a:tcP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dirty="0"/>
                        <a:t>5-Year SMART Goal</a:t>
                      </a:r>
                    </a:p>
                  </a:txBody>
                  <a:tcP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6496473"/>
                  </a:ext>
                </a:extLst>
              </a:tr>
              <a:tr h="582952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solidFill>
                            <a:schemeClr val="bg1"/>
                          </a:solidFill>
                        </a:rPr>
                        <a:t>Role #1</a:t>
                      </a:r>
                    </a:p>
                  </a:txBody>
                  <a:tcPr anchor="ctr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5700428"/>
                  </a:ext>
                </a:extLst>
              </a:tr>
              <a:tr h="672636">
                <a:tc>
                  <a:txBody>
                    <a:bodyPr/>
                    <a:lstStyle/>
                    <a:p>
                      <a:pPr algn="ctr"/>
                      <a:r>
                        <a:rPr lang="en-US" sz="2800" b="1" dirty="0">
                          <a:solidFill>
                            <a:schemeClr val="bg1"/>
                          </a:solidFill>
                        </a:rPr>
                        <a:t>Role #2</a:t>
                      </a:r>
                    </a:p>
                  </a:txBody>
                  <a:tcPr anchor="ctr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5289016"/>
                  </a:ext>
                </a:extLst>
              </a:tr>
              <a:tr h="67263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solidFill>
                            <a:schemeClr val="bg1"/>
                          </a:solidFill>
                        </a:rPr>
                        <a:t>Role #3</a:t>
                      </a:r>
                    </a:p>
                  </a:txBody>
                  <a:tcPr anchor="ctr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0708883"/>
                  </a:ext>
                </a:extLst>
              </a:tr>
              <a:tr h="67263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800" b="1" dirty="0">
                          <a:solidFill>
                            <a:schemeClr val="bg1"/>
                          </a:solidFill>
                        </a:rPr>
                        <a:t>Role #4</a:t>
                      </a:r>
                    </a:p>
                  </a:txBody>
                  <a:tcPr anchor="ctr"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>
                          <a:solidFill>
                            <a:schemeClr val="bg1"/>
                          </a:solidFill>
                        </a:rPr>
                        <a:t>“SMART Goal</a:t>
                      </a:r>
                      <a:r>
                        <a:rPr lang="en-US" b="1" i="1" dirty="0">
                          <a:solidFill>
                            <a:schemeClr val="bg1"/>
                          </a:solidFill>
                        </a:rPr>
                        <a:t>”</a:t>
                      </a:r>
                    </a:p>
                  </a:txBody>
                  <a:tcPr anchor="ctr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4023737"/>
                  </a:ext>
                </a:extLst>
              </a:tr>
            </a:tbl>
          </a:graphicData>
        </a:graphic>
      </p:graphicFrame>
      <p:sp>
        <p:nvSpPr>
          <p:cNvPr id="9" name="Title 1">
            <a:extLst>
              <a:ext uri="{FF2B5EF4-FFF2-40B4-BE49-F238E27FC236}">
                <a16:creationId xmlns:a16="http://schemas.microsoft.com/office/drawing/2014/main" id="{062F1016-0CA1-464C-93A2-ED50A139E704}"/>
              </a:ext>
            </a:extLst>
          </p:cNvPr>
          <p:cNvSpPr txBox="1">
            <a:spLocks/>
          </p:cNvSpPr>
          <p:nvPr/>
        </p:nvSpPr>
        <p:spPr>
          <a:xfrm>
            <a:off x="274320" y="365125"/>
            <a:ext cx="1165352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b="1" kern="1200">
                <a:solidFill>
                  <a:srgbClr val="57262F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ctr"/>
            <a:r>
              <a:rPr lang="en-US" dirty="0"/>
              <a:t>CORE</a:t>
            </a:r>
            <a:r>
              <a:rPr lang="en-US" baseline="-25000" dirty="0"/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6012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48978FD76C5A4FBE1B32C501F8FC88" ma:contentTypeVersion="18" ma:contentTypeDescription="Create a new document." ma:contentTypeScope="" ma:versionID="03c82302d9336b7411964d611f76f4eb">
  <xsd:schema xmlns:xsd="http://www.w3.org/2001/XMLSchema" xmlns:xs="http://www.w3.org/2001/XMLSchema" xmlns:p="http://schemas.microsoft.com/office/2006/metadata/properties" xmlns:ns2="35dab48a-e2c4-4028-ba67-19a1f1b4b8c7" xmlns:ns3="7d2e1451-08d6-4fd6-afba-a625a088b07a" targetNamespace="http://schemas.microsoft.com/office/2006/metadata/properties" ma:root="true" ma:fieldsID="439b43af8904f539fc8771fceabbee0d" ns2:_="" ns3:_="">
    <xsd:import namespace="35dab48a-e2c4-4028-ba67-19a1f1b4b8c7"/>
    <xsd:import namespace="7d2e1451-08d6-4fd6-afba-a625a088b07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Statu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WorkflowStep" minOccurs="0"/>
                <xsd:element ref="ns2:MediaServiceLocation" minOccurs="0"/>
                <xsd:element ref="ns3:SharedWithUsers" minOccurs="0"/>
                <xsd:element ref="ns3:SharedWithDetails" minOccurs="0"/>
                <xsd:element ref="ns2:Detail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5dab48a-e2c4-4028-ba67-19a1f1b4b8c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Status" ma:index="12" nillable="true" ma:displayName="Status" ma:description="File migration status" ma:format="Dropdown" ma:internalName="Status">
      <xsd:simpleType>
        <xsd:restriction base="dms:Text">
          <xsd:maxLength value="255"/>
        </xsd:restriction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cda1ba52-7d3b-4811-9808-5c9985ea513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WorkflowStep" ma:index="19" nillable="true" ma:displayName="Workflow Step" ma:description="The process relates to submissions at the following workflow step." ma:format="Dropdown" ma:internalName="WorkflowStep">
      <xsd:simpleType>
        <xsd:restriction base="dms:Choice">
          <xsd:enumeration value="Screening"/>
          <xsd:enumeration value="Peer Review"/>
          <xsd:enumeration value="Summary"/>
          <xsd:enumeration value="Preproduction"/>
          <xsd:enumeration value="Copyediting"/>
        </xsd:restriction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Details" ma:index="23" nillable="true" ma:displayName="Details" ma:format="Dropdown" ma:internalName="Details">
      <xsd:simpleType>
        <xsd:restriction base="dms:Note">
          <xsd:maxLength value="255"/>
        </xsd:restriction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2e1451-08d6-4fd6-afba-a625a088b07a" elementFormDefault="qualified">
    <xsd:import namespace="http://schemas.microsoft.com/office/2006/documentManagement/types"/>
    <xsd:import namespace="http://schemas.microsoft.com/office/infopath/2007/PartnerControls"/>
    <xsd:element name="TaxCatchAll" ma:index="15" nillable="true" ma:displayName="Taxonomy Catch All Column" ma:hidden="true" ma:list="{3a615f98-37e7-4a89-9b8a-052ff78f1e37}" ma:internalName="TaxCatchAll" ma:showField="CatchAllData" ma:web="7d2e1451-08d6-4fd6-afba-a625a088b07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F8624FE-F9E5-40B6-BD18-C5863FFBE1E2}"/>
</file>

<file path=customXml/itemProps2.xml><?xml version="1.0" encoding="utf-8"?>
<ds:datastoreItem xmlns:ds="http://schemas.openxmlformats.org/officeDocument/2006/customXml" ds:itemID="{69F1AE13-A306-437E-A986-A71522548B61}"/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8</Words>
  <Application>Microsoft Macintosh PowerPoint</Application>
  <PresentationFormat>Widescreen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an Nelson</dc:creator>
  <cp:lastModifiedBy>Ryan Nelson</cp:lastModifiedBy>
  <cp:revision>3</cp:revision>
  <dcterms:created xsi:type="dcterms:W3CDTF">2022-04-07T15:47:19Z</dcterms:created>
  <dcterms:modified xsi:type="dcterms:W3CDTF">2023-03-29T22:40:48Z</dcterms:modified>
</cp:coreProperties>
</file>